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21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LISE" initials="E" lastIdx="5" clrIdx="0">
    <p:extLst>
      <p:ext uri="{19B8F6BF-5375-455C-9EA6-DF929625EA0E}">
        <p15:presenceInfo xmlns:p15="http://schemas.microsoft.com/office/powerpoint/2012/main" userId="ELIS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E0000"/>
    <a:srgbClr val="EEEAE1"/>
    <a:srgbClr val="F7F7F7"/>
    <a:srgbClr val="00FF00"/>
    <a:srgbClr val="B686E6"/>
    <a:srgbClr val="BC5D1C"/>
    <a:srgbClr val="9AC97B"/>
    <a:srgbClr val="335AA1"/>
    <a:srgbClr val="70AD47"/>
    <a:srgbClr val="997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584" autoAdjust="0"/>
    <p:restoredTop sz="94660"/>
  </p:normalViewPr>
  <p:slideViewPr>
    <p:cSldViewPr snapToGrid="0">
      <p:cViewPr varScale="1">
        <p:scale>
          <a:sx n="79" d="100"/>
          <a:sy n="79" d="100"/>
        </p:scale>
        <p:origin x="322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418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636C90-24BC-405A-9A12-BA1DD00114A9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D67A84-EC68-40BB-9EDF-C0B77FBEB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2925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201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925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674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2339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1482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963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777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223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838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739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146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181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au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659092"/>
              </p:ext>
            </p:extLst>
          </p:nvPr>
        </p:nvGraphicFramePr>
        <p:xfrm>
          <a:off x="61415" y="430887"/>
          <a:ext cx="6735168" cy="6415239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59773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6434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5769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5769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5769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45660">
                <a:tc gridSpan="5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. </a:t>
                      </a:r>
                      <a:r>
                        <a:rPr lang="en-US" sz="11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mpact of MSI conditions on genes involved in the expression waves expressed during infection.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b="0" dirty="0">
                        <a:solidFill>
                          <a:srgbClr val="00D65C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b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102311466"/>
                  </a:ext>
                </a:extLst>
              </a:tr>
              <a:tr h="842169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gene set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 </a:t>
                      </a:r>
                      <a:r>
                        <a:rPr lang="en-US" sz="11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b</a:t>
                      </a:r>
                      <a:r>
                        <a:rPr lang="en-US" sz="110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f genes</a:t>
                      </a:r>
                      <a:endParaRPr lang="en-US" sz="11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s</a:t>
                      </a:r>
                      <a:r>
                        <a:rPr lang="en-US" sz="11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detected as DEG in MSI (</a:t>
                      </a:r>
                      <a:r>
                        <a:rPr lang="en-US" sz="1100" b="0" baseline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b</a:t>
                      </a: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percentage</a:t>
                      </a:r>
                      <a:r>
                        <a:rPr lang="en-US" sz="11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accent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OWN-regulated genes in MSI (</a:t>
                      </a:r>
                      <a:r>
                        <a:rPr lang="en-US" sz="1100" b="0" dirty="0" err="1">
                          <a:solidFill>
                            <a:schemeClr val="accent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b</a:t>
                      </a:r>
                      <a:r>
                        <a:rPr lang="en-US" sz="1100" b="0" dirty="0">
                          <a:solidFill>
                            <a:schemeClr val="accent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percent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P-regulated genes in MSI (</a:t>
                      </a:r>
                      <a:r>
                        <a:rPr lang="en-US" sz="1100" b="0" dirty="0" err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b</a:t>
                      </a:r>
                      <a:r>
                        <a:rPr lang="en-US" sz="1100" b="0" dirty="0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percent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619936">
                <a:tc>
                  <a:txBody>
                    <a:bodyPr/>
                    <a:lstStyle/>
                    <a:p>
                      <a:pPr algn="l"/>
                      <a:r>
                        <a:rPr lang="en-US" sz="1100" b="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ptosphaeria maculans </a:t>
                      </a: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isolate JN3)</a:t>
                      </a:r>
                      <a:r>
                        <a:rPr lang="en-US" sz="11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ene set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04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10 ; 17.7 %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11</a:t>
                      </a:r>
                      <a:r>
                        <a:rPr lang="en-US" sz="110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; 56.7 %</a:t>
                      </a:r>
                      <a:endParaRPr lang="en-US" sz="11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9</a:t>
                      </a:r>
                      <a:r>
                        <a:rPr lang="en-US" sz="110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; 4.3 %</a:t>
                      </a:r>
                      <a:endParaRPr lang="en-US" sz="11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797060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gene</a:t>
                      </a:r>
                      <a:r>
                        <a:rPr lang="en-US" sz="11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et involved SSI, from </a:t>
                      </a: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y </a:t>
                      </a:r>
                      <a:r>
                        <a:rPr lang="en-US" sz="1100" b="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 al, </a:t>
                      </a: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20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 </a:t>
                      </a:r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3 ; 51.8 % </a:t>
                      </a:r>
                      <a:r>
                        <a:rPr lang="en-US" sz="11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b="1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**)</a:t>
                      </a:r>
                      <a:r>
                        <a:rPr lang="en-US" sz="11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endParaRPr lang="en-US" sz="11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9 ; 52.8 %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4 ;</a:t>
                      </a:r>
                      <a:r>
                        <a:rPr lang="en-US" sz="110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47.2</a:t>
                      </a:r>
                      <a:endParaRPr lang="en-US" sz="11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65898">
                <a:tc gridSpan="5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. </a:t>
                      </a:r>
                      <a:r>
                        <a:rPr lang="en-US" sz="11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tails of deregulation in waves of expression during MSI conditions. 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7678654"/>
                  </a:ext>
                </a:extLst>
              </a:tr>
              <a:tr h="842169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waves (from Gay </a:t>
                      </a:r>
                      <a:r>
                        <a:rPr lang="en-US" sz="1100" b="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 al, </a:t>
                      </a: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)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b of genes</a:t>
                      </a:r>
                      <a:endParaRPr 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 </a:t>
                      </a: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s</a:t>
                      </a:r>
                      <a:r>
                        <a:rPr lang="en-US" sz="11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detected as DEG in MSI (</a:t>
                      </a:r>
                      <a:r>
                        <a:rPr lang="en-US" sz="1100" b="0" baseline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b</a:t>
                      </a: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percentage</a:t>
                      </a:r>
                      <a:r>
                        <a:rPr lang="en-US" sz="11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baseline="30000" dirty="0">
                          <a:solidFill>
                            <a:schemeClr val="accent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 </a:t>
                      </a:r>
                      <a:r>
                        <a:rPr lang="en-US" sz="1100" b="0" dirty="0">
                          <a:solidFill>
                            <a:schemeClr val="accent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DOWN-regulated genes in MSI (</a:t>
                      </a:r>
                      <a:r>
                        <a:rPr lang="en-US" sz="1100" b="0" dirty="0" err="1">
                          <a:solidFill>
                            <a:schemeClr val="accent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b</a:t>
                      </a:r>
                      <a:r>
                        <a:rPr lang="en-US" sz="1100" b="0" dirty="0">
                          <a:solidFill>
                            <a:schemeClr val="accent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percent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baseline="30000" dirty="0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 </a:t>
                      </a:r>
                      <a:r>
                        <a:rPr lang="en-US" sz="1100" b="0" dirty="0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UP-regulated genes in MSI (</a:t>
                      </a:r>
                      <a:r>
                        <a:rPr lang="en-US" sz="1100" b="0" dirty="0" err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b</a:t>
                      </a:r>
                      <a:r>
                        <a:rPr lang="en-US" sz="1100" b="0" dirty="0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percent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92202669"/>
                  </a:ext>
                </a:extLst>
              </a:tr>
              <a:tr h="286338">
                <a:tc>
                  <a:txBody>
                    <a:bodyPr/>
                    <a:lstStyle/>
                    <a:p>
                      <a:pPr algn="r"/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(early infection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62 ; 64.0 % </a:t>
                      </a:r>
                      <a:r>
                        <a:rPr lang="en-US" sz="1100" b="1" baseline="30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</a:t>
                      </a:r>
                      <a:r>
                        <a:rPr lang="en-US" sz="11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*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; 14%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; 50% </a:t>
                      </a:r>
                      <a:r>
                        <a:rPr lang="en-US" sz="1100" b="1" baseline="30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</a:t>
                      </a:r>
                      <a:r>
                        <a:rPr lang="en-US" sz="11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r>
                        <a:rPr lang="en-US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6338">
                <a:tc>
                  <a:txBody>
                    <a:bodyPr/>
                    <a:lstStyle/>
                    <a:p>
                      <a:pPr algn="r"/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(</a:t>
                      </a:r>
                      <a:r>
                        <a:rPr lang="en-US" sz="11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trophy</a:t>
                      </a:r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9 ; 87.1 % </a:t>
                      </a:r>
                      <a:r>
                        <a:rPr lang="en-US" sz="1100" b="1" baseline="30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</a:t>
                      </a:r>
                      <a:r>
                        <a:rPr lang="en-US" sz="11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**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9; 80.4%  </a:t>
                      </a:r>
                      <a:r>
                        <a:rPr lang="en-US" sz="1100" b="1" baseline="30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</a:t>
                      </a:r>
                      <a:r>
                        <a:rPr lang="en-US" sz="11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; 6.7%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6338">
                <a:tc>
                  <a:txBody>
                    <a:bodyPr/>
                    <a:lstStyle/>
                    <a:p>
                      <a:pPr algn="r"/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 (</a:t>
                      </a:r>
                      <a:r>
                        <a:rPr lang="en-US" sz="11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crotrophy</a:t>
                      </a:r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 ; 67.8 % </a:t>
                      </a:r>
                      <a:r>
                        <a:rPr lang="en-US" sz="1100" b="1" baseline="30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</a:t>
                      </a:r>
                      <a:r>
                        <a:rPr lang="en-US" sz="11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*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; 41%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; 26%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71615">
                <a:tc>
                  <a:txBody>
                    <a:bodyPr/>
                    <a:lstStyle/>
                    <a:p>
                      <a:pPr algn="r"/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 (transition </a:t>
                      </a:r>
                      <a:r>
                        <a:rPr lang="en-US" sz="1100" b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trophy</a:t>
                      </a:r>
                      <a:r>
                        <a:rPr lang="en-US" sz="11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o </a:t>
                      </a:r>
                      <a:r>
                        <a:rPr lang="en-US" sz="1100" b="0" baseline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crotrophy</a:t>
                      </a: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2 ; 52.2 %</a:t>
                      </a:r>
                      <a:endParaRPr lang="en-US" sz="1100" b="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86338">
                <a:tc>
                  <a:txBody>
                    <a:bodyPr/>
                    <a:lstStyle/>
                    <a:p>
                      <a:pPr algn="r"/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 (stem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 ; 32.0</a:t>
                      </a:r>
                      <a:r>
                        <a:rPr lang="en-US" sz="110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% </a:t>
                      </a:r>
                      <a:r>
                        <a:rPr lang="en-US" sz="1100" b="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 **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42811">
                <a:tc>
                  <a:txBody>
                    <a:bodyPr/>
                    <a:lstStyle/>
                    <a:p>
                      <a:pPr algn="r"/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 (stem</a:t>
                      </a:r>
                      <a:r>
                        <a:rPr lang="en-US" sz="11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b="0" baseline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crotorphy</a:t>
                      </a:r>
                      <a:r>
                        <a:rPr lang="en-US" sz="11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 ; 36.2 % </a:t>
                      </a:r>
                      <a:r>
                        <a:rPr lang="en-US" sz="1100" b="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 **</a:t>
                      </a:r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42811">
                <a:tc>
                  <a:txBody>
                    <a:bodyPr/>
                    <a:lstStyle/>
                    <a:p>
                      <a:pPr algn="r"/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 (stem and </a:t>
                      </a:r>
                      <a:r>
                        <a:rPr lang="en-US" sz="1100" b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protrophy</a:t>
                      </a: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 ; 34.9 % </a:t>
                      </a:r>
                      <a:r>
                        <a:rPr lang="en-US" sz="1100" b="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 **</a:t>
                      </a:r>
                      <a:endParaRPr lang="en-US" sz="11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86338">
                <a:tc>
                  <a:txBody>
                    <a:bodyPr/>
                    <a:lstStyle/>
                    <a:p>
                      <a:pPr algn="r"/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 (</a:t>
                      </a:r>
                      <a:r>
                        <a:rPr lang="en-US" sz="1100" b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protrophy</a:t>
                      </a: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0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 ; 53.0 %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3" name="ZoneTexte 2">
            <a:extLst>
              <a:ext uri="{FF2B5EF4-FFF2-40B4-BE49-F238E27FC236}">
                <a16:creationId xmlns:a16="http://schemas.microsoft.com/office/drawing/2014/main" id="{8AF538FB-51EC-64B4-0E28-3B30E4ED8F14}"/>
              </a:ext>
            </a:extLst>
          </p:cNvPr>
          <p:cNvSpPr txBox="1"/>
          <p:nvPr/>
        </p:nvSpPr>
        <p:spPr>
          <a:xfrm>
            <a:off x="61416" y="6935956"/>
            <a:ext cx="6735167" cy="29392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400"/>
              </a:spcAft>
            </a:pP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otal number of genes in the Lmb genome and total number of genes specifically expressed during the infectious cycle in SSI conditions (Gay et al., 2021). </a:t>
            </a:r>
            <a:endParaRPr lang="fr-FR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400"/>
              </a:spcAft>
            </a:pP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proportion of DEG in MSI in the 13,047 gene set (17.7%) was compared to the proportion of DEG in MSI in the 1,203 gene set (51.8%) by Chi-Squared test (**: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lt; 0.001, *: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lt; 0.05) . A significant proportion of DEGs previously described as involved in infectious pathways (Gay et al., 2021) are deregulated during MSI conditions.</a:t>
            </a:r>
            <a:endParaRPr lang="fr-FR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400"/>
              </a:spcAft>
            </a:pP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o detect which expression waves was significantly impacted by the MSI conditions, the proportion of DEG-MSI in each cluster was compared to the total proportion of DEG-MSI (51.8%) in the 1,207 genes involved in the infectious cycle with a Chi-Squared test (**: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lt; 0.001, *: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lt; 0.05).  Three clusters (1, 2 and 3) were found highly deregulated, with an over-representation of DEGs during MSI condition (in bold). Two clusters (5, and 6 corresponding to stem infection) were under-represented in the DEGs in MSI conditions on cotyledons.</a:t>
            </a:r>
            <a:endParaRPr lang="fr-FR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400"/>
              </a:spcAft>
            </a:pPr>
            <a:r>
              <a:rPr lang="en-US" sz="11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,e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o detect if genes in clusters 1, 2 and 3 trended to be  up- or down-regulated in MSI conditions, a second Chi-Squared test (**: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lt; 0.001, *: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lt; 0.05) was realized by comparing the proportion of down- and up-regulated genes in each cluster in MSI to the total amount of down- (52.8%) and up-regulated (47.2%) genes in MSI among the 1,207 genes set.</a:t>
            </a:r>
            <a:endParaRPr lang="fr-FR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400"/>
              </a:spcAft>
            </a:pP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d : not detected, statistical tests were only performed on over-represented clusters.</a:t>
            </a:r>
            <a:endParaRPr lang="fr-FR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996C472D-047F-0EA8-7D56-3BD02D3DF18C}"/>
              </a:ext>
            </a:extLst>
          </p:cNvPr>
          <p:cNvSpPr txBox="1"/>
          <p:nvPr/>
        </p:nvSpPr>
        <p:spPr>
          <a:xfrm>
            <a:off x="61415" y="0"/>
            <a:ext cx="6735167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22, Table S5. Impact of Mixed Species Inoculation (MSI) on the eight expression waves induced during the infectious cycle of </a:t>
            </a:r>
            <a:r>
              <a:rPr lang="en-US" sz="11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ptosphaeria maculans 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‘</a:t>
            </a:r>
            <a:r>
              <a:rPr lang="en-US" sz="11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assicae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’</a:t>
            </a:r>
            <a:r>
              <a:rPr lang="en-US" sz="11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Lmb).</a:t>
            </a:r>
            <a:endParaRPr lang="fr-FR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217526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6</TotalTime>
  <Words>619</Words>
  <Application>Microsoft Office PowerPoint</Application>
  <PresentationFormat>A4 Paper (210x297 mm)</PresentationFormat>
  <Paragraphs>6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Windows</dc:creator>
  <cp:lastModifiedBy>Graham Bell</cp:lastModifiedBy>
  <cp:revision>796</cp:revision>
  <dcterms:created xsi:type="dcterms:W3CDTF">2020-02-06T09:05:41Z</dcterms:created>
  <dcterms:modified xsi:type="dcterms:W3CDTF">2023-10-05T10:48:19Z</dcterms:modified>
</cp:coreProperties>
</file>